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62" r:id="rId2"/>
  </p:sldIdLst>
  <p:sldSz cx="6858000" cy="9144000" type="letter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3CDEF"/>
    <a:srgbClr val="FFCCCC"/>
    <a:srgbClr val="2C11F7"/>
    <a:srgbClr val="CCFFCC"/>
    <a:srgbClr val="CCCCFF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4" autoAdjust="0"/>
    <p:restoredTop sz="94660"/>
  </p:normalViewPr>
  <p:slideViewPr>
    <p:cSldViewPr snapToGrid="0">
      <p:cViewPr varScale="1">
        <p:scale>
          <a:sx n="77" d="100"/>
          <a:sy n="77" d="100"/>
        </p:scale>
        <p:origin x="24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94" d="100"/>
          <a:sy n="94" d="100"/>
        </p:scale>
        <p:origin x="28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75F1C848-E130-413A-A8DA-8172A53B0D88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4C6F3B48-2B3A-4C55-BDFB-E1E416627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3352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DCB9EB20-C2EB-4A46-8805-2479D3AB5F2C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F07D6EC-DFDD-4EE7-ACA8-6578442E63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5759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250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03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212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35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39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764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23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063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009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114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00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58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microsoft.com/office/2007/relationships/hdphoto" Target="../media/hdphoto1.wdp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47092" y="7292653"/>
            <a:ext cx="630682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teraction and expression of the native profile 4 sites before and after 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13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ranslocation. A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C assay measuring all the pair-wise interactions listed in Figure 6A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del of the interactions between profile 4 sites before and after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1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ranslocation. The interactions between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DK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XKS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ER3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TO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DR12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isappear after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1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ranslocation, indicating that these interactions may be bridged by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1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RNA level of the profile 4 genes measured by RT-PCR (normalized by that of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CT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13, ADK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TO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DR12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have significant decreas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p-values a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0007, 0.03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0.028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0.02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spectively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397" t="42083" r="28323" b="43615"/>
          <a:stretch/>
        </p:blipFill>
        <p:spPr>
          <a:xfrm>
            <a:off x="1996723" y="2402108"/>
            <a:ext cx="2185060" cy="579737"/>
          </a:xfrm>
          <a:prstGeom prst="rect">
            <a:avLst/>
          </a:prstGeom>
        </p:spPr>
      </p:pic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6826856"/>
              </p:ext>
            </p:extLst>
          </p:nvPr>
        </p:nvGraphicFramePr>
        <p:xfrm>
          <a:off x="735275" y="2006737"/>
          <a:ext cx="3256752" cy="34747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35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</a:tblGrid>
              <a:tr h="124838">
                <a:tc gridSpan="16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13</a:t>
                      </a:r>
                      <a:r>
                        <a:rPr lang="en-US" sz="900" b="1" i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ranslocation</a:t>
                      </a:r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US" sz="9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Met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18288" marB="18288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18288" marB="18288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18288" marB="18288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4838"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30" t="25147" r="34601" b="62607"/>
          <a:stretch/>
        </p:blipFill>
        <p:spPr>
          <a:xfrm>
            <a:off x="510575" y="2402108"/>
            <a:ext cx="1487254" cy="579738"/>
          </a:xfrm>
          <a:prstGeom prst="rect">
            <a:avLst/>
          </a:prstGeom>
        </p:spPr>
      </p:pic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3152115"/>
              </p:ext>
            </p:extLst>
          </p:nvPr>
        </p:nvGraphicFramePr>
        <p:xfrm>
          <a:off x="746398" y="982995"/>
          <a:ext cx="3256752" cy="34747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35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203547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</a:tblGrid>
              <a:tr h="124838">
                <a:tc gridSpan="16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genous profile 4 sites</a:t>
                      </a:r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US" sz="9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Met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18288" marB="18288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18288" marB="18288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18288" marB="18288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4838"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93" t="44052" r="29890" b="41943"/>
          <a:stretch/>
        </p:blipFill>
        <p:spPr>
          <a:xfrm>
            <a:off x="2378511" y="1364748"/>
            <a:ext cx="1745117" cy="596349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19590" y="669251"/>
            <a:ext cx="3156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19590" y="3156725"/>
            <a:ext cx="3156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259610" y="3349847"/>
            <a:ext cx="10352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13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87321" y="3835231"/>
            <a:ext cx="5672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DK1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015715" y="4401663"/>
            <a:ext cx="5703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GTO1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1009794" y="3518712"/>
            <a:ext cx="203332" cy="162434"/>
          </a:xfrm>
          <a:prstGeom prst="straightConnector1">
            <a:avLst/>
          </a:prstGeom>
          <a:ln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2001696" y="3835969"/>
            <a:ext cx="6008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ER33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Arrow Connector 36"/>
          <p:cNvCxnSpPr/>
          <p:nvPr/>
        </p:nvCxnSpPr>
        <p:spPr>
          <a:xfrm flipH="1" flipV="1">
            <a:off x="1839279" y="3519398"/>
            <a:ext cx="208596" cy="163760"/>
          </a:xfrm>
          <a:prstGeom prst="straightConnector1">
            <a:avLst/>
          </a:prstGeom>
          <a:ln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/>
          <p:nvPr/>
        </p:nvCxnSpPr>
        <p:spPr>
          <a:xfrm flipV="1">
            <a:off x="844105" y="4110168"/>
            <a:ext cx="2590" cy="228730"/>
          </a:xfrm>
          <a:prstGeom prst="straightConnector1">
            <a:avLst/>
          </a:prstGeom>
          <a:ln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581609" y="4380209"/>
            <a:ext cx="517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XKS1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263423" y="4768901"/>
            <a:ext cx="7592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DR12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2831868" y="4271194"/>
            <a:ext cx="1076442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2866873" y="3834135"/>
            <a:ext cx="10430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13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ranslocation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547128" y="3783138"/>
            <a:ext cx="576822" cy="9001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4" name="Straight Arrow Connector 53"/>
          <p:cNvCxnSpPr/>
          <p:nvPr/>
        </p:nvCxnSpPr>
        <p:spPr>
          <a:xfrm flipV="1">
            <a:off x="2274144" y="4119640"/>
            <a:ext cx="2590" cy="228730"/>
          </a:xfrm>
          <a:prstGeom prst="straightConnector1">
            <a:avLst/>
          </a:prstGeom>
          <a:ln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>
            <a:off x="1985507" y="3783138"/>
            <a:ext cx="576822" cy="9001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7" name="Straight Arrow Connector 56"/>
          <p:cNvCxnSpPr/>
          <p:nvPr/>
        </p:nvCxnSpPr>
        <p:spPr>
          <a:xfrm flipH="1" flipV="1">
            <a:off x="1228836" y="4599931"/>
            <a:ext cx="208596" cy="163760"/>
          </a:xfrm>
          <a:prstGeom prst="straightConnector1">
            <a:avLst/>
          </a:prstGeom>
          <a:ln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 flipH="1">
            <a:off x="1651000" y="4593088"/>
            <a:ext cx="203332" cy="162434"/>
          </a:xfrm>
          <a:prstGeom prst="straightConnector1">
            <a:avLst/>
          </a:prstGeom>
          <a:ln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 flipH="1">
            <a:off x="1228343" y="4202570"/>
            <a:ext cx="620461" cy="0"/>
          </a:xfrm>
          <a:prstGeom prst="straightConnector1">
            <a:avLst/>
          </a:prstGeom>
          <a:ln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4159045" y="3837296"/>
            <a:ext cx="5672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DK1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Straight Arrow Connector 71"/>
          <p:cNvCxnSpPr/>
          <p:nvPr/>
        </p:nvCxnSpPr>
        <p:spPr>
          <a:xfrm flipV="1">
            <a:off x="4415829" y="4112233"/>
            <a:ext cx="2590" cy="228730"/>
          </a:xfrm>
          <a:prstGeom prst="straightConnector1">
            <a:avLst/>
          </a:prstGeom>
          <a:ln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4153333" y="4382274"/>
            <a:ext cx="517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XKS1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"/>
          <p:cNvSpPr/>
          <p:nvPr/>
        </p:nvSpPr>
        <p:spPr>
          <a:xfrm>
            <a:off x="4118852" y="3785203"/>
            <a:ext cx="576822" cy="9001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TextBox 81"/>
          <p:cNvSpPr txBox="1"/>
          <p:nvPr/>
        </p:nvSpPr>
        <p:spPr>
          <a:xfrm>
            <a:off x="5437711" y="4402697"/>
            <a:ext cx="5703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GTO1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5423692" y="3837003"/>
            <a:ext cx="6008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ER33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Straight Arrow Connector 85"/>
          <p:cNvCxnSpPr/>
          <p:nvPr/>
        </p:nvCxnSpPr>
        <p:spPr>
          <a:xfrm flipV="1">
            <a:off x="5696140" y="4120674"/>
            <a:ext cx="2590" cy="228730"/>
          </a:xfrm>
          <a:prstGeom prst="straightConnector1">
            <a:avLst/>
          </a:prstGeom>
          <a:ln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Rectangle 86"/>
          <p:cNvSpPr/>
          <p:nvPr/>
        </p:nvSpPr>
        <p:spPr>
          <a:xfrm>
            <a:off x="5407503" y="3784172"/>
            <a:ext cx="576822" cy="9001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TextBox 87"/>
          <p:cNvSpPr txBox="1"/>
          <p:nvPr/>
        </p:nvSpPr>
        <p:spPr>
          <a:xfrm>
            <a:off x="4799743" y="4763691"/>
            <a:ext cx="7592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DR12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Straight Arrow Connector 88"/>
          <p:cNvCxnSpPr/>
          <p:nvPr/>
        </p:nvCxnSpPr>
        <p:spPr>
          <a:xfrm flipH="1" flipV="1">
            <a:off x="4743561" y="4590406"/>
            <a:ext cx="208596" cy="163760"/>
          </a:xfrm>
          <a:prstGeom prst="straightConnector1">
            <a:avLst/>
          </a:prstGeom>
          <a:ln>
            <a:solidFill>
              <a:schemeClr val="bg2">
                <a:lumMod val="90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/>
          <p:nvPr/>
        </p:nvCxnSpPr>
        <p:spPr>
          <a:xfrm flipH="1">
            <a:off x="5165725" y="4583563"/>
            <a:ext cx="203332" cy="162434"/>
          </a:xfrm>
          <a:prstGeom prst="straightConnector1">
            <a:avLst/>
          </a:prstGeom>
          <a:ln>
            <a:solidFill>
              <a:schemeClr val="bg2">
                <a:lumMod val="90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/>
          <p:cNvCxnSpPr/>
          <p:nvPr/>
        </p:nvCxnSpPr>
        <p:spPr>
          <a:xfrm flipH="1">
            <a:off x="4743068" y="4193045"/>
            <a:ext cx="620461" cy="0"/>
          </a:xfrm>
          <a:prstGeom prst="straightConnector1">
            <a:avLst/>
          </a:prstGeom>
          <a:ln>
            <a:solidFill>
              <a:schemeClr val="bg2">
                <a:lumMod val="90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Down Arrow 49"/>
          <p:cNvSpPr/>
          <p:nvPr/>
        </p:nvSpPr>
        <p:spPr>
          <a:xfrm>
            <a:off x="4952157" y="3650865"/>
            <a:ext cx="213568" cy="438122"/>
          </a:xfrm>
          <a:prstGeom prst="downArrow">
            <a:avLst/>
          </a:prstGeom>
          <a:solidFill>
            <a:srgbClr val="2C11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TextBox 93"/>
          <p:cNvSpPr txBox="1"/>
          <p:nvPr/>
        </p:nvSpPr>
        <p:spPr>
          <a:xfrm>
            <a:off x="4523606" y="3353772"/>
            <a:ext cx="11236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rgbClr val="2C11F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raction lost</a:t>
            </a:r>
            <a:endParaRPr lang="en-US" sz="1000" b="1" dirty="0">
              <a:solidFill>
                <a:srgbClr val="2C11F7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219" t="40959" r="29753" b="44622"/>
          <a:stretch/>
        </p:blipFill>
        <p:spPr>
          <a:xfrm>
            <a:off x="593965" y="1367917"/>
            <a:ext cx="1811465" cy="590914"/>
          </a:xfrm>
          <a:prstGeom prst="rect">
            <a:avLst/>
          </a:prstGeom>
        </p:spPr>
      </p:pic>
      <p:cxnSp>
        <p:nvCxnSpPr>
          <p:cNvPr id="45" name="Straight Arrow Connector 44"/>
          <p:cNvCxnSpPr/>
          <p:nvPr/>
        </p:nvCxnSpPr>
        <p:spPr>
          <a:xfrm flipV="1">
            <a:off x="1534547" y="3672307"/>
            <a:ext cx="4026" cy="1073690"/>
          </a:xfrm>
          <a:prstGeom prst="straightConnector1">
            <a:avLst/>
          </a:prstGeom>
          <a:ln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5440496" y="297899"/>
            <a:ext cx="11107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u_Fig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7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19590" y="5071630"/>
            <a:ext cx="3156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8"/>
          <a:srcRect l="8986" t="6211" r="12499" b="24562"/>
          <a:stretch/>
        </p:blipFill>
        <p:spPr>
          <a:xfrm>
            <a:off x="857250" y="5124450"/>
            <a:ext cx="3028950" cy="2047876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2118537" y="5194325"/>
            <a:ext cx="1789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sz="1000" b="1" i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13</a:t>
            </a:r>
            <a:r>
              <a:rPr lang="en-US" sz="10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ranslocation</a:t>
            </a:r>
            <a:endParaRPr lang="en-US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136268" y="6925944"/>
            <a:ext cx="3655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13 SER33  XKS1  ADK1  GTO1  PDR1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6200000">
            <a:off x="221011" y="5970112"/>
            <a:ext cx="11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[mRNA] / [</a:t>
            </a:r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CT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1402858" y="5312327"/>
            <a:ext cx="158985" cy="658569"/>
            <a:chOff x="1375562" y="5312327"/>
            <a:chExt cx="158985" cy="658569"/>
          </a:xfrm>
        </p:grpSpPr>
        <p:sp>
          <p:nvSpPr>
            <p:cNvPr id="53" name="Left Bracket 52"/>
            <p:cNvSpPr/>
            <p:nvPr/>
          </p:nvSpPr>
          <p:spPr>
            <a:xfrm rot="5400000">
              <a:off x="1427185" y="5260704"/>
              <a:ext cx="55740" cy="158985"/>
            </a:xfrm>
            <a:prstGeom prst="leftBracket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6" name="Straight Connector 55"/>
            <p:cNvCxnSpPr/>
            <p:nvPr/>
          </p:nvCxnSpPr>
          <p:spPr>
            <a:xfrm>
              <a:off x="1534547" y="5368067"/>
              <a:ext cx="0" cy="602829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3" name="Left Bracket 62"/>
          <p:cNvSpPr/>
          <p:nvPr/>
        </p:nvSpPr>
        <p:spPr>
          <a:xfrm rot="5400000">
            <a:off x="1868888" y="5603208"/>
            <a:ext cx="55740" cy="158985"/>
          </a:xfrm>
          <a:prstGeom prst="lef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Left Bracket 63"/>
          <p:cNvSpPr/>
          <p:nvPr/>
        </p:nvSpPr>
        <p:spPr>
          <a:xfrm rot="5400000">
            <a:off x="2274238" y="5943918"/>
            <a:ext cx="55740" cy="158985"/>
          </a:xfrm>
          <a:prstGeom prst="lef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Left Bracket 64"/>
          <p:cNvSpPr/>
          <p:nvPr/>
        </p:nvSpPr>
        <p:spPr>
          <a:xfrm rot="5400000">
            <a:off x="2682124" y="5693943"/>
            <a:ext cx="55740" cy="158985"/>
          </a:xfrm>
          <a:prstGeom prst="lef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Left Bracket 65"/>
          <p:cNvSpPr/>
          <p:nvPr/>
        </p:nvSpPr>
        <p:spPr>
          <a:xfrm rot="5400000">
            <a:off x="3080512" y="5691749"/>
            <a:ext cx="55740" cy="158985"/>
          </a:xfrm>
          <a:prstGeom prst="lef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Left Bracket 66"/>
          <p:cNvSpPr/>
          <p:nvPr/>
        </p:nvSpPr>
        <p:spPr>
          <a:xfrm rot="5400000">
            <a:off x="3509167" y="5691750"/>
            <a:ext cx="55740" cy="158985"/>
          </a:xfrm>
          <a:prstGeom prst="lef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TextBox 67"/>
          <p:cNvSpPr txBox="1"/>
          <p:nvPr/>
        </p:nvSpPr>
        <p:spPr>
          <a:xfrm>
            <a:off x="1339875" y="5140945"/>
            <a:ext cx="4656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720829" y="5455916"/>
            <a:ext cx="4656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2130801" y="5810776"/>
            <a:ext cx="4656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2592757" y="5572071"/>
            <a:ext cx="29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2987622" y="5566478"/>
            <a:ext cx="29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414573" y="5566478"/>
            <a:ext cx="29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47227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3</TotalTime>
  <Words>209</Words>
  <Application>Microsoft Office PowerPoint</Application>
  <PresentationFormat>Letter Paper (8.5x11 in)</PresentationFormat>
  <Paragraphs>6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yu Du</dc:creator>
  <cp:lastModifiedBy>lucybai</cp:lastModifiedBy>
  <cp:revision>281</cp:revision>
  <cp:lastPrinted>2016-12-22T22:05:19Z</cp:lastPrinted>
  <dcterms:created xsi:type="dcterms:W3CDTF">2016-06-14T18:48:14Z</dcterms:created>
  <dcterms:modified xsi:type="dcterms:W3CDTF">2017-03-30T15:24:07Z</dcterms:modified>
</cp:coreProperties>
</file>